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8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139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61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905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659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412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186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03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369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68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180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99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C6929-4D81-47A4-8380-6A391B5E3541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FA044-2837-4FAB-A2D4-CFE3CA3B63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37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2073" y="5367864"/>
            <a:ext cx="7857067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Plasma FHR5/</a:t>
            </a:r>
            <a:r>
              <a:rPr lang="en-GB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atio is not associated with </a:t>
            </a:r>
            <a:r>
              <a:rPr lang="en-GB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: FHR5/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healthy controls and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atients. We did not identify a significant difference in plasma FHR5/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between healthy controls (grey box) and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atients (white box). </a:t>
            </a:r>
          </a:p>
          <a:p>
            <a:pPr algn="just">
              <a:lnSpc>
                <a:spcPct val="150000"/>
              </a:lnSpc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: FHR5/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stable and progressive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There was no significant difference in plasma FHR5/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atio between patients with stable (grey boxes) and progressive (white boxes)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t the same 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FHR1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genotype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02074" y="67417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628050" y="29520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8566" y="709546"/>
            <a:ext cx="5199925" cy="2098550"/>
          </a:xfrm>
          <a:prstGeom prst="rect">
            <a:avLst/>
          </a:prstGeom>
        </p:spPr>
      </p:pic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3641577"/>
              </p:ext>
            </p:extLst>
          </p:nvPr>
        </p:nvGraphicFramePr>
        <p:xfrm>
          <a:off x="1926646" y="2946597"/>
          <a:ext cx="4583765" cy="18359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4" imgW="3335937" imgH="2375576" progId="Prism6.Document">
                  <p:embed/>
                </p:oleObj>
              </mc:Choice>
              <mc:Fallback>
                <p:oleObj name="Prism 6" r:id="rId4" imgW="3335937" imgH="237557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26646" y="2946597"/>
                        <a:ext cx="4583765" cy="18359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82307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Reed Elsevi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ed Elsevier</dc:creator>
  <cp:lastModifiedBy>Reed Elsevier</cp:lastModifiedBy>
  <cp:revision>1</cp:revision>
  <dcterms:created xsi:type="dcterms:W3CDTF">2017-04-25T15:05:41Z</dcterms:created>
  <dcterms:modified xsi:type="dcterms:W3CDTF">2017-04-25T15:05:54Z</dcterms:modified>
</cp:coreProperties>
</file>